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  <p:sldId id="258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118" d="100"/>
          <a:sy n="118" d="100"/>
        </p:scale>
        <p:origin x="192" y="-4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379292-D649-8B1F-E7D9-DA79DD65C8D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F06FFB5-A6D5-C11F-72E9-9A1B5D21CE9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EE82CD-41B9-C2F2-0A0D-509AC06CD9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B9646-BF3E-4758-9569-2D3EBCC82846}" type="datetimeFigureOut">
              <a:rPr lang="en-IN" smtClean="0"/>
              <a:t>17-07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FF9EFF-DDDA-EF14-5E04-B0A80E3C50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74CB83-FFE9-5D3F-FF49-652355F15D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6B4BA-73BE-46F6-B694-12953C2C3C0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615544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2EE936-023E-243F-202A-17F1AB1179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DC7DF65-DDE9-00BE-B335-4037837F822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0E9704-1D0E-A117-C207-ED709A7612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B9646-BF3E-4758-9569-2D3EBCC82846}" type="datetimeFigureOut">
              <a:rPr lang="en-IN" smtClean="0"/>
              <a:t>17-07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067CF3-9AB5-993C-0163-800F45C4DA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17406D-4743-0835-F12A-0A3872AA89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6B4BA-73BE-46F6-B694-12953C2C3C0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961142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36001A0-3483-ED1E-0427-D74759A0A82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93BFA2C-1F60-65EC-9E0B-8B6A157CC24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C0E731-8630-FC1A-09BC-B4C8720E32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B9646-BF3E-4758-9569-2D3EBCC82846}" type="datetimeFigureOut">
              <a:rPr lang="en-IN" smtClean="0"/>
              <a:t>17-07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FEF832-312D-0510-F794-8172E33393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A07323-9620-4E2D-2125-E33F6DE668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6B4BA-73BE-46F6-B694-12953C2C3C0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959096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C574F7-AA39-5181-AE18-C88C3A9307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34483EA-EA2C-1DB5-540F-5E94075BD50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21EEFE-2F16-93B9-AC7B-9AA5276462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B9646-BF3E-4758-9569-2D3EBCC82846}" type="datetimeFigureOut">
              <a:rPr lang="en-IN" smtClean="0"/>
              <a:t>17-07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A8B146-0633-5DB5-870F-082CD3F80D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2C9ED3-BA1B-BFCD-2623-BAD944EDAB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6B4BA-73BE-46F6-B694-12953C2C3C0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99661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F4B9D8-D112-0689-1ACC-7C94BC6DFE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D6BC387-D83D-245D-1E02-0F5BBCB941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A71CA7-B8B5-0645-2A92-3594A866F7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B9646-BF3E-4758-9569-2D3EBCC82846}" type="datetimeFigureOut">
              <a:rPr lang="en-IN" smtClean="0"/>
              <a:t>17-07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928E9A-FAB3-2A9D-959A-859FD0F181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476641-F105-0A43-D233-9DDB179E2C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6B4BA-73BE-46F6-B694-12953C2C3C0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994239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84DF60-A6B1-A253-CDDB-0815BD35B8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7C9303-BADD-F401-5EEB-009BD21A67B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2C808E7-4EFE-2622-3FA0-5A311F97FF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AD3A7B6-D5FF-5609-8E3D-ACA1414869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B9646-BF3E-4758-9569-2D3EBCC82846}" type="datetimeFigureOut">
              <a:rPr lang="en-IN" smtClean="0"/>
              <a:t>17-07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58F4E49-8C23-5A6C-2A2B-583B72AE85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A933FA-92F9-1145-A7CF-4440A38DBD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6B4BA-73BE-46F6-B694-12953C2C3C0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403121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A428CA-B8C2-BB6F-0AC2-FD923F5848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282C921-E0A5-FC34-670B-7A56A72305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8FA6A32-6991-C782-2F56-0E5D0B886FE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E61A575-DEA0-10F5-B11D-F7019A7A941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11759B1-C025-4DAB-126F-FD88E065275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FE7106B-B46E-58A7-E3F0-5CCC5623B8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B9646-BF3E-4758-9569-2D3EBCC82846}" type="datetimeFigureOut">
              <a:rPr lang="en-IN" smtClean="0"/>
              <a:t>17-07-2025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823D386-7945-4602-6D30-C99BD8D9E9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B62C842-2507-C85F-3334-C0BE0FEBB2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6B4BA-73BE-46F6-B694-12953C2C3C0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210823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0CC62B-F537-427B-BD46-7C3FD20666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7040D38-3454-69B7-9DEF-0D2B92C426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B9646-BF3E-4758-9569-2D3EBCC82846}" type="datetimeFigureOut">
              <a:rPr lang="en-IN" smtClean="0"/>
              <a:t>17-07-2025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ED80579-1DE7-AF3D-FE3D-66E27F4A75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8445BDD-D332-8622-2871-7A3AE85C67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6B4BA-73BE-46F6-B694-12953C2C3C0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374228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2115247-EA4B-B088-F713-FC4D563A23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B9646-BF3E-4758-9569-2D3EBCC82846}" type="datetimeFigureOut">
              <a:rPr lang="en-IN" smtClean="0"/>
              <a:t>17-07-2025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BC4518E-6735-475D-852B-1D5B497C33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5A5D834-3D06-EF59-CD1C-5C55A980C0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6B4BA-73BE-46F6-B694-12953C2C3C0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551232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801B34-04B0-869B-EE1E-86D4FA0E6D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B521653-ABB3-381C-2370-66CA96E6E05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688CBC8-6FD4-9D7A-986C-7861A97DC4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902A20E-5960-D4FC-0FF5-E9C0B8135B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B9646-BF3E-4758-9569-2D3EBCC82846}" type="datetimeFigureOut">
              <a:rPr lang="en-IN" smtClean="0"/>
              <a:t>17-07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560A1B2-F16B-118B-7257-42296E105B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417AECD-38CF-55F9-285C-B348C7F075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6B4BA-73BE-46F6-B694-12953C2C3C0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369635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2F75FE-8394-2147-DA51-9204275859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E0AC744-3FFE-FC81-6E81-0A390A948E0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30ACEBF-D2DE-49CB-D612-C8F4D4C353C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B0D33FC-0C02-27FE-D95F-43AEF6DDFF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B9646-BF3E-4758-9569-2D3EBCC82846}" type="datetimeFigureOut">
              <a:rPr lang="en-IN" smtClean="0"/>
              <a:t>17-07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ABA1BC-1654-D313-4F04-D8CE8C7A73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772E4F4-8A27-E30B-1AC5-3EC6E44CFC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6B4BA-73BE-46F6-B694-12953C2C3C0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934208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7E3DF72-33D5-D6E1-9C79-80368FD469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805392-C3AA-30BE-4C47-246C410426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4D61D5-4903-366D-CEC3-D0CB42D176F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BB9646-BF3E-4758-9569-2D3EBCC82846}" type="datetimeFigureOut">
              <a:rPr lang="en-IN" smtClean="0"/>
              <a:t>17-07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A79C8B-D1E5-3565-E76E-9B78C2C4F4C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999EFC-B546-D562-D032-BF7B8C5D176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66B4BA-73BE-46F6-B694-12953C2C3C0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008353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jpg"/><Relationship Id="rId4" Type="http://schemas.openxmlformats.org/officeDocument/2006/relationships/image" Target="../media/image7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jpg"/><Relationship Id="rId4" Type="http://schemas.openxmlformats.org/officeDocument/2006/relationships/image" Target="../media/image11.jp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B73FE9A-091B-3216-03F0-915D8727D3E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775" y="850781"/>
            <a:ext cx="5109920" cy="227592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B09B057-E84E-78E1-2155-8AAB89DD7330}"/>
              </a:ext>
            </a:extLst>
          </p:cNvPr>
          <p:cNvSpPr txBox="1"/>
          <p:nvPr/>
        </p:nvSpPr>
        <p:spPr>
          <a:xfrm>
            <a:off x="944115" y="176980"/>
            <a:ext cx="1015650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ry Fig 1 : </a:t>
            </a:r>
            <a:r>
              <a:rPr lang="en-US" sz="1200" dirty="0" err="1"/>
              <a:t>Bootscanning</a:t>
            </a:r>
            <a:r>
              <a:rPr lang="en-US" sz="1200" dirty="0"/>
              <a:t> analysis of the FMDV serotype A ORF, generated using RDP 5.0. The plots illustrate all thirteen recombination events identified in the study. Event numbering corresponds to that presented in Table 3.</a:t>
            </a:r>
            <a:endParaRPr lang="en-IN" sz="12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0489E5B-C163-ABB9-48EA-32F7CF601F44}"/>
              </a:ext>
            </a:extLst>
          </p:cNvPr>
          <p:cNvSpPr txBox="1"/>
          <p:nvPr/>
        </p:nvSpPr>
        <p:spPr>
          <a:xfrm>
            <a:off x="1915899" y="3200337"/>
            <a:ext cx="23705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/>
              <a:t>HQ832592_17/09/India/2009 (1)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1E0C0839-D88B-397D-95F9-F34CDD71D9D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6042" y="3577411"/>
            <a:ext cx="5610225" cy="2524125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F4A4FB1D-E98D-D2FB-8A1F-2657AFBE00A6}"/>
              </a:ext>
            </a:extLst>
          </p:cNvPr>
          <p:cNvSpPr txBox="1"/>
          <p:nvPr/>
        </p:nvSpPr>
        <p:spPr>
          <a:xfrm>
            <a:off x="1730695" y="6193869"/>
            <a:ext cx="245784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200" dirty="0"/>
              <a:t>HQ832590_245/07_India/2007 (2) 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43E1E330-E8A0-6070-096F-44B1661BF99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06267" y="691781"/>
            <a:ext cx="5610225" cy="2543175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8AA91BF9-23CD-94D7-3C40-C4BC967BCA63}"/>
              </a:ext>
            </a:extLst>
          </p:cNvPr>
          <p:cNvSpPr txBox="1"/>
          <p:nvPr/>
        </p:nvSpPr>
        <p:spPr>
          <a:xfrm>
            <a:off x="7905594" y="3174965"/>
            <a:ext cx="207460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200" dirty="0"/>
              <a:t>AY593776/Germany/1944 (3)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BDA438B5-4530-22DB-A0EB-56B6CD47552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3477336"/>
            <a:ext cx="5467350" cy="2667000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00C76F08-1D56-051E-8C6E-95E3CA2F253E}"/>
              </a:ext>
            </a:extLst>
          </p:cNvPr>
          <p:cNvSpPr txBox="1"/>
          <p:nvPr/>
        </p:nvSpPr>
        <p:spPr>
          <a:xfrm>
            <a:off x="8288376" y="6041240"/>
            <a:ext cx="214343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200" dirty="0"/>
              <a:t>LC564908/Thailand/2012 (4)</a:t>
            </a:r>
          </a:p>
        </p:txBody>
      </p:sp>
    </p:spTree>
    <p:extLst>
      <p:ext uri="{BB962C8B-B14F-4D97-AF65-F5344CB8AC3E}">
        <p14:creationId xmlns:p14="http://schemas.microsoft.com/office/powerpoint/2010/main" val="26461837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DE52BEE-FF1B-A47C-B630-5BAA307491B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660" y="344129"/>
            <a:ext cx="5267325" cy="25908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A05FB0D-1102-F1E8-8E1B-BFF1E63FED5C}"/>
              </a:ext>
            </a:extLst>
          </p:cNvPr>
          <p:cNvSpPr txBox="1"/>
          <p:nvPr/>
        </p:nvSpPr>
        <p:spPr>
          <a:xfrm>
            <a:off x="1691148" y="2934929"/>
            <a:ext cx="206477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LC564907/Thailand/2011 (5)</a:t>
            </a:r>
            <a:endParaRPr lang="en-IN" sz="1200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789D1EF8-9B45-CE8E-4918-830806ACFA9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1085" y="3274297"/>
            <a:ext cx="5276850" cy="2657475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9C4E0EF3-45AF-5205-112C-24A809A721DA}"/>
              </a:ext>
            </a:extLst>
          </p:cNvPr>
          <p:cNvSpPr txBox="1"/>
          <p:nvPr/>
        </p:nvSpPr>
        <p:spPr>
          <a:xfrm>
            <a:off x="1809135" y="5994141"/>
            <a:ext cx="267437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Q832577_110/99_India/1999 (6)</a:t>
            </a:r>
            <a:endParaRPr lang="en-IN" sz="1200" dirty="0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C5FF3668-C423-37DA-A011-F21943F0585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511203"/>
            <a:ext cx="5591175" cy="2562225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C409EF37-AC12-1FD9-F021-B62281E9C2FC}"/>
              </a:ext>
            </a:extLst>
          </p:cNvPr>
          <p:cNvSpPr txBox="1"/>
          <p:nvPr/>
        </p:nvSpPr>
        <p:spPr>
          <a:xfrm>
            <a:off x="8055999" y="3012894"/>
            <a:ext cx="256284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200" dirty="0"/>
              <a:t>IND84(202)/11/India/2011 (7)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1B65AB38-908F-6BBC-4F04-CECCAD2E28F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19850" y="3336667"/>
            <a:ext cx="5267325" cy="260032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26441B6-BB49-0ADC-043C-E4D89A5B1C63}"/>
              </a:ext>
            </a:extLst>
          </p:cNvPr>
          <p:cNvSpPr txBox="1"/>
          <p:nvPr/>
        </p:nvSpPr>
        <p:spPr>
          <a:xfrm>
            <a:off x="8259097" y="5989369"/>
            <a:ext cx="255638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Y593751_Netherlands/1942 (8)</a:t>
            </a:r>
            <a:endParaRPr lang="en-IN" sz="1200" dirty="0"/>
          </a:p>
        </p:txBody>
      </p:sp>
    </p:spTree>
    <p:extLst>
      <p:ext uri="{BB962C8B-B14F-4D97-AF65-F5344CB8AC3E}">
        <p14:creationId xmlns:p14="http://schemas.microsoft.com/office/powerpoint/2010/main" val="17327894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6DB6370-421A-6989-9374-4670A90A48C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5120" y="495761"/>
            <a:ext cx="5305425" cy="254317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5A38476-8D8C-3411-7115-608EAF68811C}"/>
              </a:ext>
            </a:extLst>
          </p:cNvPr>
          <p:cNvSpPr txBox="1"/>
          <p:nvPr/>
        </p:nvSpPr>
        <p:spPr>
          <a:xfrm>
            <a:off x="1474839" y="3038936"/>
            <a:ext cx="345112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N227144_27(68)/11/India/2011 (9)</a:t>
            </a:r>
            <a:endParaRPr lang="en-IN" sz="1400" dirty="0"/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7B2ADC8C-B980-E9EC-1362-758EB7A592B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5120" y="3761914"/>
            <a:ext cx="5267325" cy="2600325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331A76B3-5B1A-AEDC-F333-9AB53C26B50A}"/>
              </a:ext>
            </a:extLst>
          </p:cNvPr>
          <p:cNvSpPr txBox="1"/>
          <p:nvPr/>
        </p:nvSpPr>
        <p:spPr>
          <a:xfrm>
            <a:off x="1474839" y="6408108"/>
            <a:ext cx="352978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Q832587_50/06/India/2006 (10) </a:t>
            </a:r>
            <a:endParaRPr lang="en-IN" sz="1200" dirty="0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31B6D801-46B0-DD1C-D929-FE8A2C0159E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438611"/>
            <a:ext cx="5267325" cy="2600325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F7D5DC6B-79E9-3F7A-EB60-02CA4B270D67}"/>
              </a:ext>
            </a:extLst>
          </p:cNvPr>
          <p:cNvSpPr txBox="1"/>
          <p:nvPr/>
        </p:nvSpPr>
        <p:spPr>
          <a:xfrm>
            <a:off x="7875640" y="2977381"/>
            <a:ext cx="200578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IC69/19/India/2019 (11)</a:t>
            </a:r>
            <a:endParaRPr lang="en-IN" sz="1200" dirty="0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212460D9-ADBF-A921-D39A-709FFE1D6F4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72378" y="3603621"/>
            <a:ext cx="5248275" cy="2543175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7E01C09F-09F1-B3B5-BC1B-3B0B47C56FDC}"/>
              </a:ext>
            </a:extLst>
          </p:cNvPr>
          <p:cNvSpPr txBox="1"/>
          <p:nvPr/>
        </p:nvSpPr>
        <p:spPr>
          <a:xfrm>
            <a:off x="8209935" y="6146796"/>
            <a:ext cx="250722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ND84(202)/11/India/2011 (12)</a:t>
            </a:r>
            <a:endParaRPr lang="en-IN" sz="1200" dirty="0"/>
          </a:p>
        </p:txBody>
      </p:sp>
    </p:spTree>
    <p:extLst>
      <p:ext uri="{BB962C8B-B14F-4D97-AF65-F5344CB8AC3E}">
        <p14:creationId xmlns:p14="http://schemas.microsoft.com/office/powerpoint/2010/main" val="23648231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FA59098-BFFD-CBA4-2ADD-1868EE6AB69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565" y="234586"/>
            <a:ext cx="5267325" cy="260985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0D1F96D-EFC6-210A-CFA3-67AC35E5DAFF}"/>
              </a:ext>
            </a:extLst>
          </p:cNvPr>
          <p:cNvSpPr txBox="1"/>
          <p:nvPr/>
        </p:nvSpPr>
        <p:spPr>
          <a:xfrm>
            <a:off x="1799303" y="2924789"/>
            <a:ext cx="269403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Q832586_43/06_India/2006 (13)</a:t>
            </a:r>
            <a:endParaRPr lang="en-IN" sz="1200" dirty="0"/>
          </a:p>
        </p:txBody>
      </p:sp>
    </p:spTree>
    <p:extLst>
      <p:ext uri="{BB962C8B-B14F-4D97-AF65-F5344CB8AC3E}">
        <p14:creationId xmlns:p14="http://schemas.microsoft.com/office/powerpoint/2010/main" val="40199817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4</TotalTime>
  <Words>150</Words>
  <Application>Microsoft Office PowerPoint</Application>
  <PresentationFormat>Widescreen</PresentationFormat>
  <Paragraphs>1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aravanan Subramaniam</dc:creator>
  <cp:lastModifiedBy>Saravanan Subramaniam</cp:lastModifiedBy>
  <cp:revision>5</cp:revision>
  <dcterms:created xsi:type="dcterms:W3CDTF">2025-07-07T10:58:02Z</dcterms:created>
  <dcterms:modified xsi:type="dcterms:W3CDTF">2025-07-17T06:07:25Z</dcterms:modified>
</cp:coreProperties>
</file>